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32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BF676-81C1-58AA-3E34-2ED02C8D9B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8F5FA2-223D-945C-6EA5-7B82773851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85ACF0-2CF6-2C0A-59CD-98D6FB163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73629-E8A3-101C-6C3B-ACC2B5B1F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30B58-82D3-E14B-D47A-6DF450282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5116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1092AF-83E4-DDB8-B8FA-C4052FAB89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1F5E59-8116-F00C-3C0E-82DC783E6A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E490BE-ADF4-AE9A-0897-95BC5D269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6362FC-93F0-8C28-4DF8-F92F09B40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2DF166-8F7C-4290-CB85-E4E8C141B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061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FC9017-56F2-AA91-E863-6CA2FE059D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83AF26-3C68-8FD4-E7B1-87D76DD027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3DDFBE-AF75-C006-898E-EF011B6AF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A24C46-AA97-FC27-ACFB-FE02263FA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F6B195-B66F-4FDD-EB5E-ED77FE62C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7585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E0366-C4FC-B6BE-3601-CAC7C3CEB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89FC2A-F533-C9E2-0493-1B3E8D4C4A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1E7479-4639-3697-8779-8196A1F2F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762C6A-69A2-815E-9776-AE2BDBD13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83296C-88C0-11D1-EB24-4D6684D65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7643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DE7FFF-98ED-A38A-8D21-1E5FB5AA20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474011-6693-61E7-EC18-01ABCBD133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BEB00-9BD5-BE50-9C3F-A8D565A1E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FC2289-93E5-0028-F192-ACBC697E1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33179-0764-8043-6206-716179041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5411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C5B03-B741-A7DA-FEE1-5D00359DCC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1F7B13-2D43-BD65-66EC-0FF445E84A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CBB2D4-2A14-EB46-5393-E5CA1F73E9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C1F77D-2A35-989D-FEF8-9DCAFD743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F98E10-B67A-6F68-BE86-11CB082A3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E76D6F-5BE3-3E25-E16C-EBEE028AA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9177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0FE92-72D4-BF9E-C938-C3590DD9F8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3408FE-3E83-7481-A46C-7BDD9DBA8A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3F872C-76D2-6F22-0308-D88327DDDB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E3B806-0C8F-CC77-37CE-739B30F4DE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BB552C-CDBB-0B96-771C-B7A61020AD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F68429-F86C-9422-A3CC-9922BCD25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E73243-49AC-ADEE-8B5A-1B021F6D7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EBDB67-11DF-153D-CF0B-3B658BFAB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8018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F9437-863B-3D59-8E2B-2287BAD3EC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1F3F5C6-5097-3C4F-179B-C31DCAE2C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7EAF0D-18F0-6F97-D9D5-5F7F599A2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8BD611-01C8-C1A0-D416-C1A775650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1126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A105F3-F6FF-8F61-8A86-96B80B653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5DDD80-CC8E-2FE2-C0B8-3F3C118BC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4B408D-0B30-63E4-B8EC-E518BA4FB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8515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64B13-5F70-8928-1B77-6BFD9FE27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BA8E7B-93E0-2B81-E8CC-6E9F44789F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D8516F-BD34-E066-D464-F944CE54CC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CC1371-2DBD-A1C3-C1FF-B2637C239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DC25C6-5C29-121E-09AD-74F1E15A3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505A52-4D68-BD5A-6114-08156B643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4489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F0770-BFBC-4832-6C9A-116B5590E0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DD01C6-974E-95FE-5B0B-D7B70F2BAF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812A03-D7A1-079C-AC78-DEB74EA5B2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9BC7D5-4FC6-302E-DEF8-735E2E549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671C44-8CBD-2D2A-F1D2-CED7F8834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83360D-D652-7FF5-E66E-67596858C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5017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B0FF91-6C3B-5DD8-60EE-303293085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E14B72-713A-0476-0234-6508FEE5F4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D1F1C-1638-066E-59EB-E504442003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0E9172-D835-440A-A5CD-C2C92856ACE5}" type="datetimeFigureOut">
              <a:rPr lang="de-DE" smtClean="0"/>
              <a:t>14.05.2026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DEF13B-C00A-DA35-C7D1-04EB496EEA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1B9583-E731-F67D-2131-7E1065BEAF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8AD92C-C092-4B6D-95CE-B4DBB6FB43E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0919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49369A3-0054-7681-438B-55448830F2C9}"/>
              </a:ext>
            </a:extLst>
          </p:cNvPr>
          <p:cNvGrpSpPr/>
          <p:nvPr/>
        </p:nvGrpSpPr>
        <p:grpSpPr>
          <a:xfrm>
            <a:off x="2572333" y="215199"/>
            <a:ext cx="6575425" cy="5733626"/>
            <a:chOff x="2572333" y="215199"/>
            <a:chExt cx="6575425" cy="573362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037D0D4-CEAD-654A-EC77-E4FBD5FBB885}"/>
                </a:ext>
              </a:extLst>
            </p:cNvPr>
            <p:cNvGrpSpPr/>
            <p:nvPr/>
          </p:nvGrpSpPr>
          <p:grpSpPr>
            <a:xfrm>
              <a:off x="2572333" y="215199"/>
              <a:ext cx="6575425" cy="2797540"/>
              <a:chOff x="1200733" y="1308772"/>
              <a:chExt cx="6575425" cy="2797540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F1CC53D7-3F56-F201-9D30-7356FD0417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00733" y="1602507"/>
                <a:ext cx="3424555" cy="2503805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49CD3CA-6E2E-7FB0-F3E4-FEBD3F42C105}"/>
                  </a:ext>
                </a:extLst>
              </p:cNvPr>
              <p:cNvSpPr txBox="1"/>
              <p:nvPr/>
            </p:nvSpPr>
            <p:spPr>
              <a:xfrm>
                <a:off x="1672643" y="1308772"/>
                <a:ext cx="3137071" cy="29373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800"/>
                  </a:spcAft>
                </a:pPr>
                <a:r>
                  <a:rPr lang="en-US" sz="1200" b="1" kern="100" dirty="0">
                    <a:effectLst/>
                    <a:latin typeface="Calibri" panose="020F050202020403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5cholA</a:t>
                </a:r>
                <a:r>
                  <a:rPr lang="en-US" sz="1200" kern="100" dirty="0">
                    <a:effectLst/>
                    <a:latin typeface="Calibri" panose="020F050202020403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 (Example of a Low Abundant Bile Acid)</a:t>
                </a:r>
                <a:endParaRPr lang="de-DE" sz="12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975751A9-DDAE-0FEA-9A1A-199EF78E0D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474418" y="1727083"/>
                <a:ext cx="6301740" cy="1748028"/>
              </a:xfrm>
              <a:prstGeom prst="rect">
                <a:avLst/>
              </a:prstGeom>
            </p:spPr>
          </p:pic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FBF8E5AE-658D-643B-347F-37403B5103A6}"/>
                </a:ext>
              </a:extLst>
            </p:cNvPr>
            <p:cNvGrpSpPr/>
            <p:nvPr/>
          </p:nvGrpSpPr>
          <p:grpSpPr>
            <a:xfrm>
              <a:off x="2572334" y="3137315"/>
              <a:ext cx="6575424" cy="2811510"/>
              <a:chOff x="2572333" y="3754604"/>
              <a:chExt cx="6575424" cy="281151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ADB33D2-D85A-31F1-AD6D-9756FB4904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572333" y="4048339"/>
                <a:ext cx="3475355" cy="2517775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74240CA4-81D2-F681-A3F1-D050878ECF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846017" y="3994115"/>
                <a:ext cx="6301740" cy="1798320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761C9FD-FD3E-7956-B3FC-0CB138667A7D}"/>
                  </a:ext>
                </a:extLst>
              </p:cNvPr>
              <p:cNvSpPr txBox="1"/>
              <p:nvPr/>
            </p:nvSpPr>
            <p:spPr>
              <a:xfrm>
                <a:off x="3044243" y="3754604"/>
                <a:ext cx="4941158" cy="29373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ct val="115000"/>
                  </a:lnSpc>
                  <a:spcAft>
                    <a:spcPts val="800"/>
                  </a:spcAft>
                </a:pPr>
                <a:r>
                  <a:rPr lang="en-US" sz="1200" kern="1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TCDCA (Example </a:t>
                </a:r>
                <a:r>
                  <a:rPr lang="en-US" sz="1200" kern="100" dirty="0">
                    <a:effectLst/>
                    <a:latin typeface="Calibri" panose="020F050202020403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of a high Abundant Bile Acid</a:t>
                </a:r>
                <a:r>
                  <a:rPr lang="en-US" sz="1200" kern="1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Aptos" panose="020B0004020202020204" pitchFamily="34" charset="0"/>
                    <a:cs typeface="Times New Roman" panose="02020603050405020304" pitchFamily="18" charset="0"/>
                  </a:rPr>
                  <a:t>)</a:t>
                </a:r>
                <a:endParaRPr lang="de-DE" sz="12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A2265682-291B-6EE7-E11E-FE1CBEDA92F7}"/>
              </a:ext>
            </a:extLst>
          </p:cNvPr>
          <p:cNvSpPr txBox="1"/>
          <p:nvPr/>
        </p:nvSpPr>
        <p:spPr>
          <a:xfrm>
            <a:off x="1007074" y="6125767"/>
            <a:ext cx="9428205" cy="4465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Bland-Altman analysis plots of 5cholA and TCDCA from each human liver tissue sample classically homogenized with the </a:t>
            </a:r>
            <a:r>
              <a:rPr lang="en-US" sz="1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ssueLyzer</a:t>
            </a:r>
            <a:r>
              <a:rPr lang="en-US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ablated with the NIRL (n=10). Each liver tissue piece which was halved is matched to the corresponding homogenization method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1941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ka</dc:creator>
  <cp:lastModifiedBy>Manka</cp:lastModifiedBy>
  <cp:revision>1</cp:revision>
  <dcterms:created xsi:type="dcterms:W3CDTF">2026-05-13T11:45:49Z</dcterms:created>
  <dcterms:modified xsi:type="dcterms:W3CDTF">2026-05-14T03:16:47Z</dcterms:modified>
</cp:coreProperties>
</file>